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3" r:id="rId3"/>
    <p:sldId id="26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1/08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07449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56602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1/08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552071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ltese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240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Benefits of technology in older people with diabetes</a:t>
            </a:r>
            <a:endParaRPr lang="en-GB" sz="1800" b="1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9B42928-6EE8-1FC6-AFB1-ADD8B3B15B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68404" y="759261"/>
            <a:ext cx="4807193" cy="5190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552071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ltese et al (2024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4-06240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Key barriers to the use of technology in older people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FC9E18D-6438-9A06-D26A-26ECC092D9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69222" y="836712"/>
            <a:ext cx="5005556" cy="5040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44153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5520714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Maltese et al (2024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4-06240-2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Research questions related to diabetes technology in older people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03F1F33-E0BD-F7EA-4C43-A33D7E6B18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89004" y="783239"/>
            <a:ext cx="4565993" cy="50940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8667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</Words>
  <Application>Microsoft Office PowerPoint</Application>
  <PresentationFormat>On-screen Show (4:3)</PresentationFormat>
  <Paragraphs>1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8</cp:revision>
  <dcterms:created xsi:type="dcterms:W3CDTF">2016-06-15T12:53:43Z</dcterms:created>
  <dcterms:modified xsi:type="dcterms:W3CDTF">2024-08-01T10:17:26Z</dcterms:modified>
</cp:coreProperties>
</file>